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14" d="100"/>
          <a:sy n="114" d="100"/>
        </p:scale>
        <p:origin x="-354" y="-3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F7D1C-8F9D-425D-AB5B-EC503F034553}" type="datetimeFigureOut">
              <a:rPr lang="en-GB" smtClean="0"/>
              <a:t>14/0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F1BFDE-C71E-44B2-B615-A73598DDC667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29831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F7D1C-8F9D-425D-AB5B-EC503F034553}" type="datetimeFigureOut">
              <a:rPr lang="en-GB" smtClean="0"/>
              <a:t>14/0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F1BFDE-C71E-44B2-B615-A73598DDC667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22370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F7D1C-8F9D-425D-AB5B-EC503F034553}" type="datetimeFigureOut">
              <a:rPr lang="en-GB" smtClean="0"/>
              <a:t>14/0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F1BFDE-C71E-44B2-B615-A73598DDC667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741011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F7D1C-8F9D-425D-AB5B-EC503F034553}" type="datetimeFigureOut">
              <a:rPr lang="en-GB" smtClean="0"/>
              <a:t>14/0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F1BFDE-C71E-44B2-B615-A73598DDC667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65868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F7D1C-8F9D-425D-AB5B-EC503F034553}" type="datetimeFigureOut">
              <a:rPr lang="en-GB" smtClean="0"/>
              <a:t>14/0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F1BFDE-C71E-44B2-B615-A73598DDC667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8084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F7D1C-8F9D-425D-AB5B-EC503F034553}" type="datetimeFigureOut">
              <a:rPr lang="en-GB" smtClean="0"/>
              <a:t>14/0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F1BFDE-C71E-44B2-B615-A73598DDC667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70888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F7D1C-8F9D-425D-AB5B-EC503F034553}" type="datetimeFigureOut">
              <a:rPr lang="en-GB" smtClean="0"/>
              <a:t>14/0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F1BFDE-C71E-44B2-B615-A73598DDC667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37380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F7D1C-8F9D-425D-AB5B-EC503F034553}" type="datetimeFigureOut">
              <a:rPr lang="en-GB" smtClean="0"/>
              <a:t>14/0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F1BFDE-C71E-44B2-B615-A73598DDC667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68674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F7D1C-8F9D-425D-AB5B-EC503F034553}" type="datetimeFigureOut">
              <a:rPr lang="en-GB" smtClean="0"/>
              <a:t>14/0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F1BFDE-C71E-44B2-B615-A73598DDC667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98772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F7D1C-8F9D-425D-AB5B-EC503F034553}" type="datetimeFigureOut">
              <a:rPr lang="en-GB" smtClean="0"/>
              <a:t>14/0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F1BFDE-C71E-44B2-B615-A73598DDC667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613965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F7D1C-8F9D-425D-AB5B-EC503F034553}" type="datetimeFigureOut">
              <a:rPr lang="en-GB" smtClean="0"/>
              <a:t>14/0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F1BFDE-C71E-44B2-B615-A73598DDC667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45417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1F7D1C-8F9D-425D-AB5B-EC503F034553}" type="datetimeFigureOut">
              <a:rPr lang="en-GB" smtClean="0"/>
              <a:t>14/0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F1BFDE-C71E-44B2-B615-A73598DDC667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2967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1699" y="0"/>
            <a:ext cx="10097405" cy="6259422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0" y="6111332"/>
            <a:ext cx="121249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a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– Rank abundance plots of the families detected  using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taPhlAn2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the four metagenomes.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-axis, abundances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expressed as percentage of the reads mapping on taxonomically informative marker genes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; X-axis, families detected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117388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0780" y="0"/>
            <a:ext cx="10287740" cy="6255237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6111332"/>
            <a:ext cx="121249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b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– Rank abundance plots of the species detected  using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taPhlAn2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the four metagenomes.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-axis, 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bundancec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expressed as percentage of the reads mapping on taxonomically informative marker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s); X-axis, species detected, excluding the ones with abundance &lt;</a:t>
            </a:r>
            <a:r>
              <a:rPr lang="en-GB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1%.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391001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88</Words>
  <Application>Microsoft Office PowerPoint</Application>
  <PresentationFormat>Personalizzato</PresentationFormat>
  <Paragraphs>2</Paragraphs>
  <Slides>2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3" baseType="lpstr">
      <vt:lpstr>Office Theme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sposito, Alfonso</dc:creator>
  <cp:lastModifiedBy>Olivier Jousson</cp:lastModifiedBy>
  <cp:revision>10</cp:revision>
  <dcterms:created xsi:type="dcterms:W3CDTF">2018-06-08T06:02:04Z</dcterms:created>
  <dcterms:modified xsi:type="dcterms:W3CDTF">2018-09-14T12:44:25Z</dcterms:modified>
</cp:coreProperties>
</file>